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C922F-0956-4CEC-BFBF-DFA8F6C58C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F6014-348C-41C9-80BB-080D70A45E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53876-46BA-42B7-9D6D-B01DAC1867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6AAD2-BCD5-49CA-9C0F-21C0DA795F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98580-B705-4B69-8744-69BE6F34CE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15CB1-4DB9-4A97-87D8-670CA960C4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4FDC4-1651-42A1-8D4A-F5A8FC7875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4FE07-4E6B-48C2-B649-8B1E7443D8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20C26-F29A-4B2A-8D8B-7DFB5494BC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93F51-76A8-4AE1-BD5C-EC85AAB066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EAC26-A45A-4B17-8894-261E2E7325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B03B7-A470-485C-9444-C33E7A1F2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EE369E-81E2-42A8-8A49-34CE1CC47E34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82040" y="711360"/>
            <a:ext cx="823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ig. S4   FREP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92280" y="2327400"/>
            <a:ext cx="3747600" cy="3837960"/>
            <a:chOff x="1592280" y="2327400"/>
            <a:chExt cx="3747600" cy="3837960"/>
          </a:xfrm>
        </p:grpSpPr>
        <p:sp>
          <p:nvSpPr>
            <p:cNvPr id="43" name=""/>
            <p:cNvSpPr/>
            <p:nvPr/>
          </p:nvSpPr>
          <p:spPr>
            <a:xfrm>
              <a:off x="1592280" y="3330360"/>
              <a:ext cx="1731960" cy="1922040"/>
            </a:xfrm>
            <a:custGeom>
              <a:avLst/>
              <a:gdLst/>
              <a:ahLst/>
              <a:rect l="l" t="t" r="r" b="b"/>
              <a:pathLst>
                <a:path w="1046" h="1124">
                  <a:moveTo>
                    <a:pt x="1046" y="599"/>
                  </a:moveTo>
                  <a:lnTo>
                    <a:pt x="671" y="938"/>
                  </a:lnTo>
                  <a:cubicBezTo>
                    <a:pt x="564" y="1022"/>
                    <a:pt x="501" y="1124"/>
                    <a:pt x="401" y="1106"/>
                  </a:cubicBezTo>
                  <a:cubicBezTo>
                    <a:pt x="301" y="1088"/>
                    <a:pt x="128" y="977"/>
                    <a:pt x="68" y="827"/>
                  </a:cubicBezTo>
                  <a:cubicBezTo>
                    <a:pt x="8" y="677"/>
                    <a:pt x="0" y="339"/>
                    <a:pt x="38" y="206"/>
                  </a:cubicBezTo>
                  <a:cubicBezTo>
                    <a:pt x="76" y="73"/>
                    <a:pt x="183" y="0"/>
                    <a:pt x="299" y="26"/>
                  </a:cubicBezTo>
                  <a:cubicBezTo>
                    <a:pt x="415" y="52"/>
                    <a:pt x="611" y="267"/>
                    <a:pt x="734" y="362"/>
                  </a:cubicBezTo>
                  <a:lnTo>
                    <a:pt x="1046" y="599"/>
                  </a:lnTo>
                  <a:close/>
                </a:path>
              </a:pathLst>
            </a:custGeom>
            <a:gradFill rotWithShape="0">
              <a:gsLst>
                <a:gs pos="0">
                  <a:srgbClr val="bbe0e3"/>
                </a:gs>
                <a:gs pos="100000">
                  <a:srgbClr val="ffffff"/>
                </a:gs>
              </a:gsLst>
              <a:lin ang="108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504960" y="4428720"/>
              <a:ext cx="1581120" cy="1349280"/>
            </a:xfrm>
            <a:custGeom>
              <a:avLst/>
              <a:gdLst/>
              <a:ahLst/>
              <a:rect l="l" t="t" r="r" b="b"/>
              <a:pathLst>
                <a:path w="996" h="850">
                  <a:moveTo>
                    <a:pt x="0" y="0"/>
                  </a:moveTo>
                  <a:lnTo>
                    <a:pt x="369" y="39"/>
                  </a:lnTo>
                  <a:lnTo>
                    <a:pt x="738" y="60"/>
                  </a:lnTo>
                  <a:cubicBezTo>
                    <a:pt x="837" y="73"/>
                    <a:pt x="930" y="73"/>
                    <a:pt x="963" y="120"/>
                  </a:cubicBezTo>
                  <a:cubicBezTo>
                    <a:pt x="996" y="167"/>
                    <a:pt x="973" y="266"/>
                    <a:pt x="939" y="342"/>
                  </a:cubicBezTo>
                  <a:cubicBezTo>
                    <a:pt x="905" y="418"/>
                    <a:pt x="840" y="505"/>
                    <a:pt x="756" y="579"/>
                  </a:cubicBezTo>
                  <a:cubicBezTo>
                    <a:pt x="672" y="653"/>
                    <a:pt x="521" y="754"/>
                    <a:pt x="432" y="789"/>
                  </a:cubicBezTo>
                  <a:cubicBezTo>
                    <a:pt x="343" y="824"/>
                    <a:pt x="271" y="850"/>
                    <a:pt x="219" y="789"/>
                  </a:cubicBezTo>
                  <a:lnTo>
                    <a:pt x="117" y="42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ffffff"/>
                </a:gs>
                <a:gs pos="100000">
                  <a:srgbClr val="ffccff"/>
                </a:gs>
              </a:gsLst>
              <a:lin ang="135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35200" y="4624200"/>
              <a:ext cx="949320" cy="1204560"/>
            </a:xfrm>
            <a:custGeom>
              <a:avLst/>
              <a:gdLst/>
              <a:ahLst/>
              <a:rect l="l" t="t" r="r" b="b"/>
              <a:pathLst>
                <a:path w="598" h="759">
                  <a:moveTo>
                    <a:pt x="424" y="0"/>
                  </a:moveTo>
                  <a:lnTo>
                    <a:pt x="586" y="579"/>
                  </a:lnTo>
                  <a:cubicBezTo>
                    <a:pt x="598" y="701"/>
                    <a:pt x="583" y="711"/>
                    <a:pt x="496" y="735"/>
                  </a:cubicBezTo>
                  <a:cubicBezTo>
                    <a:pt x="409" y="759"/>
                    <a:pt x="128" y="759"/>
                    <a:pt x="64" y="723"/>
                  </a:cubicBezTo>
                  <a:cubicBezTo>
                    <a:pt x="0" y="687"/>
                    <a:pt x="49" y="639"/>
                    <a:pt x="109" y="519"/>
                  </a:cubicBezTo>
                  <a:cubicBezTo>
                    <a:pt x="169" y="399"/>
                    <a:pt x="359" y="108"/>
                    <a:pt x="424" y="0"/>
                  </a:cubicBezTo>
                  <a:close/>
                </a:path>
              </a:pathLst>
            </a:custGeom>
            <a:gradFill rotWithShape="0">
              <a:gsLst>
                <a:gs pos="0">
                  <a:srgbClr val="ffff99"/>
                </a:gs>
                <a:gs pos="100000">
                  <a:srgbClr val="ffffff"/>
                </a:gs>
              </a:gsLst>
              <a:lin ang="54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868400" y="5968800"/>
              <a:ext cx="171360" cy="12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743120" y="6143400"/>
              <a:ext cx="38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786200" y="4365360"/>
              <a:ext cx="258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2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566960" y="4571640"/>
              <a:ext cx="23184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1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679640" y="4817880"/>
              <a:ext cx="24768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1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411440" y="4982760"/>
              <a:ext cx="252360" cy="9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2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244760" y="5086080"/>
              <a:ext cx="222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159080" y="5268600"/>
              <a:ext cx="273240" cy="8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2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135320" y="5468760"/>
              <a:ext cx="25560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2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917880" y="556056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6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670200" y="5700600"/>
              <a:ext cx="23976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2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565440" y="5783040"/>
              <a:ext cx="266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3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359160" y="5568840"/>
              <a:ext cx="1951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171600" y="5667120"/>
              <a:ext cx="1954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976480" y="5375160"/>
              <a:ext cx="1951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733480" y="5640120"/>
              <a:ext cx="1936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36680" y="5520960"/>
              <a:ext cx="48564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179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039760" y="5356080"/>
              <a:ext cx="554040" cy="9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188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009520" y="5032080"/>
              <a:ext cx="489240" cy="9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3028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807920" y="4841640"/>
              <a:ext cx="47160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3028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725480" y="4678200"/>
              <a:ext cx="428760" cy="9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55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693800" y="4460760"/>
              <a:ext cx="422280" cy="9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95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635120" y="4208040"/>
              <a:ext cx="49032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1035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635120" y="4009680"/>
              <a:ext cx="434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864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807920" y="3844800"/>
              <a:ext cx="53208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3183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670040" y="3646080"/>
              <a:ext cx="423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678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833480" y="3522240"/>
              <a:ext cx="54756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324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139840" y="329364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309760" y="3132000"/>
              <a:ext cx="26172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2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433600" y="2835000"/>
              <a:ext cx="1951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20880" y="2838240"/>
              <a:ext cx="198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67040" y="2638080"/>
              <a:ext cx="19512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7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074760" y="2549160"/>
              <a:ext cx="457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959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403440" y="2647800"/>
              <a:ext cx="21924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614760" y="2631960"/>
              <a:ext cx="500040" cy="914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m GB1190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987720" y="2779560"/>
              <a:ext cx="1936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c 5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356000" y="2911320"/>
              <a:ext cx="463680" cy="9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Scabrou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576680" y="3095280"/>
              <a:ext cx="25884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3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486320" y="3458880"/>
              <a:ext cx="290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MS PGothic"/>
                </a:rPr>
                <a:t>Ag 6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593960" y="363492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851360" y="3736800"/>
              <a:ext cx="47916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MS PGothic"/>
                </a:rPr>
                <a:t>Dm CG766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959360" y="4082760"/>
              <a:ext cx="222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Aa 1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"/>
            <p:cNvGrpSpPr/>
            <p:nvPr/>
          </p:nvGrpSpPr>
          <p:grpSpPr>
            <a:xfrm>
              <a:off x="1892160" y="2742840"/>
              <a:ext cx="3088800" cy="2937960"/>
              <a:chOff x="1892160" y="2742840"/>
              <a:chExt cx="3088800" cy="2937960"/>
            </a:xfrm>
          </p:grpSpPr>
          <p:sp>
            <p:nvSpPr>
              <p:cNvPr id="89" name=""/>
              <p:cNvSpPr/>
              <p:nvPr/>
            </p:nvSpPr>
            <p:spPr>
              <a:xfrm flipH="1">
                <a:off x="3587400" y="2909160"/>
                <a:ext cx="453600" cy="9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H="1">
                <a:off x="3588480" y="2977560"/>
                <a:ext cx="733320" cy="893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 flipH="1">
                <a:off x="3458880" y="3874680"/>
                <a:ext cx="129600" cy="20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H="1">
                <a:off x="3453840" y="2742840"/>
                <a:ext cx="358560" cy="134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H="1">
                <a:off x="3391920" y="4084200"/>
                <a:ext cx="64800" cy="15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H="1">
                <a:off x="3362040" y="2761560"/>
                <a:ext cx="166320" cy="115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258720" y="2744280"/>
                <a:ext cx="97920" cy="117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H="1">
                <a:off x="3355200" y="3925440"/>
                <a:ext cx="1080" cy="123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991960" y="2777400"/>
                <a:ext cx="363240" cy="128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820600" y="3028320"/>
                <a:ext cx="7560" cy="31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3354120" y="4060080"/>
                <a:ext cx="1080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569680" y="2947320"/>
                <a:ext cx="257040" cy="11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829960" y="3060000"/>
                <a:ext cx="531720" cy="108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362040" y="4147560"/>
                <a:ext cx="26640" cy="9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H="1">
                <a:off x="3526920" y="3158640"/>
                <a:ext cx="1002960" cy="102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H="1">
                <a:off x="3728160" y="3534840"/>
                <a:ext cx="733320" cy="534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H="1">
                <a:off x="3723840" y="3715920"/>
                <a:ext cx="823680" cy="354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H="1">
                <a:off x="3512880" y="4073040"/>
                <a:ext cx="212400" cy="12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H="1">
                <a:off x="3388680" y="4236480"/>
                <a:ext cx="252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H="1">
                <a:off x="3404520" y="4193640"/>
                <a:ext cx="109080" cy="80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H="1">
                <a:off x="3568320" y="3825360"/>
                <a:ext cx="1412640" cy="41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3568320" y="4134600"/>
                <a:ext cx="1369800" cy="11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H="1">
                <a:off x="3405960" y="4245840"/>
                <a:ext cx="16164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H="1">
                <a:off x="3389040" y="4277880"/>
                <a:ext cx="1224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376080" y="4298400"/>
                <a:ext cx="612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H="1">
                <a:off x="3377880" y="4280760"/>
                <a:ext cx="13680" cy="1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382560" y="4347720"/>
                <a:ext cx="56880" cy="29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441240" y="4377600"/>
                <a:ext cx="1304640" cy="2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785760" y="4533480"/>
                <a:ext cx="753840" cy="75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784320" y="4536360"/>
                <a:ext cx="877320" cy="31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H="1" flipV="1">
                <a:off x="3655080" y="4509360"/>
                <a:ext cx="128520" cy="25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657240" y="4509360"/>
                <a:ext cx="163080" cy="10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822480" y="4617360"/>
                <a:ext cx="623520" cy="36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816000" y="4620600"/>
                <a:ext cx="472680" cy="45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438000" y="4376160"/>
                <a:ext cx="15480" cy="25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533400" y="4461840"/>
                <a:ext cx="12348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534840" y="4461840"/>
                <a:ext cx="64800" cy="95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600000" y="4555440"/>
                <a:ext cx="596520" cy="69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598560" y="4555440"/>
                <a:ext cx="16920" cy="4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615840" y="4598280"/>
                <a:ext cx="290160" cy="969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615840" y="4596840"/>
                <a:ext cx="496440" cy="894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453840" y="4398480"/>
                <a:ext cx="77760" cy="61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452400" y="4404600"/>
                <a:ext cx="236160" cy="1255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H="1">
                <a:off x="3365280" y="4347720"/>
                <a:ext cx="20160" cy="1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 flipH="1">
                <a:off x="3333240" y="4358880"/>
                <a:ext cx="31680" cy="94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H="1">
                <a:off x="3297960" y="4450680"/>
                <a:ext cx="36360" cy="27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H="1">
                <a:off x="3268080" y="4722120"/>
                <a:ext cx="3132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H="1">
                <a:off x="2782080" y="4771440"/>
                <a:ext cx="495000" cy="85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 flipH="1">
                <a:off x="3106080" y="4790520"/>
                <a:ext cx="164520" cy="558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300120" y="4720680"/>
                <a:ext cx="108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301560" y="4760280"/>
                <a:ext cx="126720" cy="790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 flipH="1">
                <a:off x="3228480" y="4763520"/>
                <a:ext cx="71280" cy="88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 flipH="1">
                <a:off x="3155400" y="4452480"/>
                <a:ext cx="179280" cy="240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 flipH="1">
                <a:off x="2368080" y="4696920"/>
                <a:ext cx="784080" cy="64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 flipH="1">
                <a:off x="2571120" y="4696920"/>
                <a:ext cx="583560" cy="78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H="1">
                <a:off x="3330000" y="4360320"/>
                <a:ext cx="3312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 flipH="1">
                <a:off x="3278880" y="4363560"/>
                <a:ext cx="5364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H="1">
                <a:off x="3206520" y="4385520"/>
                <a:ext cx="7560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H="1">
                <a:off x="2156760" y="4396680"/>
                <a:ext cx="1047240" cy="31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H="1" flipV="1">
                <a:off x="3163320" y="4392000"/>
                <a:ext cx="39600" cy="2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 flipH="1">
                <a:off x="2081880" y="4393800"/>
                <a:ext cx="1096920" cy="12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V="1">
                <a:off x="2280960" y="4448880"/>
                <a:ext cx="891720" cy="43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 flipH="1">
                <a:off x="2406240" y="4450680"/>
                <a:ext cx="771120" cy="57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H="1">
                <a:off x="3169440" y="4387320"/>
                <a:ext cx="107640" cy="59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1892160" y="4295160"/>
                <a:ext cx="1272960" cy="96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2057040" y="4082400"/>
                <a:ext cx="1114200" cy="218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306160" y="3947400"/>
                <a:ext cx="869760" cy="35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3180960" y="4301640"/>
                <a:ext cx="3600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201400" y="3614040"/>
                <a:ext cx="1018800" cy="69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219120" y="4311000"/>
                <a:ext cx="11376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2461680" y="3223800"/>
                <a:ext cx="642600" cy="79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287080" y="3391920"/>
                <a:ext cx="819000" cy="626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106440" y="4019040"/>
                <a:ext cx="266400" cy="283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flipV="1">
                <a:off x="2125440" y="3621960"/>
                <a:ext cx="8028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flipH="1">
                <a:off x="3679200" y="5665320"/>
                <a:ext cx="7560" cy="1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690360" y="5662080"/>
                <a:ext cx="1440" cy="2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5" name=""/>
            <p:cNvSpPr/>
            <p:nvPr/>
          </p:nvSpPr>
          <p:spPr>
            <a:xfrm>
              <a:off x="2322360" y="2466720"/>
              <a:ext cx="1284480" cy="302760"/>
            </a:xfrm>
            <a:custGeom>
              <a:avLst/>
              <a:gdLst/>
              <a:ahLst/>
              <a:rect l="l" t="t" r="r" b="b"/>
              <a:pathLst>
                <a:path w="810" h="191">
                  <a:moveTo>
                    <a:pt x="0" y="191"/>
                  </a:moveTo>
                  <a:cubicBezTo>
                    <a:pt x="26" y="174"/>
                    <a:pt x="53" y="157"/>
                    <a:pt x="75" y="144"/>
                  </a:cubicBezTo>
                  <a:cubicBezTo>
                    <a:pt x="97" y="131"/>
                    <a:pt x="112" y="124"/>
                    <a:pt x="133" y="114"/>
                  </a:cubicBezTo>
                  <a:cubicBezTo>
                    <a:pt x="154" y="104"/>
                    <a:pt x="178" y="93"/>
                    <a:pt x="204" y="83"/>
                  </a:cubicBezTo>
                  <a:cubicBezTo>
                    <a:pt x="230" y="73"/>
                    <a:pt x="257" y="63"/>
                    <a:pt x="288" y="53"/>
                  </a:cubicBezTo>
                  <a:cubicBezTo>
                    <a:pt x="319" y="43"/>
                    <a:pt x="354" y="32"/>
                    <a:pt x="394" y="24"/>
                  </a:cubicBezTo>
                  <a:cubicBezTo>
                    <a:pt x="434" y="16"/>
                    <a:pt x="490" y="9"/>
                    <a:pt x="525" y="5"/>
                  </a:cubicBezTo>
                  <a:cubicBezTo>
                    <a:pt x="560" y="1"/>
                    <a:pt x="574" y="0"/>
                    <a:pt x="604" y="0"/>
                  </a:cubicBezTo>
                  <a:cubicBezTo>
                    <a:pt x="634" y="0"/>
                    <a:pt x="671" y="0"/>
                    <a:pt x="705" y="2"/>
                  </a:cubicBezTo>
                  <a:cubicBezTo>
                    <a:pt x="739" y="4"/>
                    <a:pt x="774" y="9"/>
                    <a:pt x="810" y="14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3794040" y="2523960"/>
              <a:ext cx="739800" cy="385200"/>
            </a:xfrm>
            <a:custGeom>
              <a:avLst/>
              <a:gdLst/>
              <a:ahLst/>
              <a:rect l="l" t="t" r="r" b="b"/>
              <a:pathLst>
                <a:path w="465" h="243">
                  <a:moveTo>
                    <a:pt x="0" y="0"/>
                  </a:moveTo>
                  <a:cubicBezTo>
                    <a:pt x="35" y="10"/>
                    <a:pt x="70" y="20"/>
                    <a:pt x="96" y="29"/>
                  </a:cubicBezTo>
                  <a:cubicBezTo>
                    <a:pt x="122" y="38"/>
                    <a:pt x="135" y="43"/>
                    <a:pt x="158" y="53"/>
                  </a:cubicBezTo>
                  <a:cubicBezTo>
                    <a:pt x="181" y="63"/>
                    <a:pt x="210" y="75"/>
                    <a:pt x="236" y="89"/>
                  </a:cubicBezTo>
                  <a:cubicBezTo>
                    <a:pt x="262" y="103"/>
                    <a:pt x="295" y="121"/>
                    <a:pt x="318" y="135"/>
                  </a:cubicBezTo>
                  <a:cubicBezTo>
                    <a:pt x="341" y="149"/>
                    <a:pt x="358" y="162"/>
                    <a:pt x="375" y="173"/>
                  </a:cubicBezTo>
                  <a:cubicBezTo>
                    <a:pt x="392" y="184"/>
                    <a:pt x="402" y="192"/>
                    <a:pt x="417" y="204"/>
                  </a:cubicBezTo>
                  <a:cubicBezTo>
                    <a:pt x="432" y="216"/>
                    <a:pt x="448" y="229"/>
                    <a:pt x="465" y="243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035080" y="5476680"/>
              <a:ext cx="1560600" cy="534600"/>
            </a:xfrm>
            <a:custGeom>
              <a:avLst/>
              <a:gdLst/>
              <a:ahLst/>
              <a:rect l="l" t="t" r="r" b="b"/>
              <a:pathLst>
                <a:path w="982" h="337">
                  <a:moveTo>
                    <a:pt x="0" y="0"/>
                  </a:moveTo>
                  <a:cubicBezTo>
                    <a:pt x="16" y="16"/>
                    <a:pt x="32" y="32"/>
                    <a:pt x="46" y="44"/>
                  </a:cubicBezTo>
                  <a:cubicBezTo>
                    <a:pt x="60" y="56"/>
                    <a:pt x="70" y="66"/>
                    <a:pt x="82" y="75"/>
                  </a:cubicBezTo>
                  <a:cubicBezTo>
                    <a:pt x="94" y="84"/>
                    <a:pt x="100" y="90"/>
                    <a:pt x="115" y="101"/>
                  </a:cubicBezTo>
                  <a:cubicBezTo>
                    <a:pt x="130" y="112"/>
                    <a:pt x="158" y="133"/>
                    <a:pt x="175" y="144"/>
                  </a:cubicBezTo>
                  <a:cubicBezTo>
                    <a:pt x="192" y="155"/>
                    <a:pt x="197" y="157"/>
                    <a:pt x="216" y="168"/>
                  </a:cubicBezTo>
                  <a:cubicBezTo>
                    <a:pt x="235" y="179"/>
                    <a:pt x="267" y="198"/>
                    <a:pt x="289" y="210"/>
                  </a:cubicBezTo>
                  <a:cubicBezTo>
                    <a:pt x="311" y="222"/>
                    <a:pt x="328" y="231"/>
                    <a:pt x="348" y="240"/>
                  </a:cubicBezTo>
                  <a:cubicBezTo>
                    <a:pt x="368" y="249"/>
                    <a:pt x="388" y="256"/>
                    <a:pt x="409" y="263"/>
                  </a:cubicBezTo>
                  <a:cubicBezTo>
                    <a:pt x="430" y="270"/>
                    <a:pt x="447" y="277"/>
                    <a:pt x="472" y="284"/>
                  </a:cubicBezTo>
                  <a:cubicBezTo>
                    <a:pt x="497" y="291"/>
                    <a:pt x="534" y="302"/>
                    <a:pt x="562" y="308"/>
                  </a:cubicBezTo>
                  <a:cubicBezTo>
                    <a:pt x="590" y="314"/>
                    <a:pt x="609" y="319"/>
                    <a:pt x="639" y="323"/>
                  </a:cubicBezTo>
                  <a:cubicBezTo>
                    <a:pt x="669" y="327"/>
                    <a:pt x="708" y="331"/>
                    <a:pt x="741" y="333"/>
                  </a:cubicBezTo>
                  <a:cubicBezTo>
                    <a:pt x="774" y="335"/>
                    <a:pt x="805" y="337"/>
                    <a:pt x="837" y="336"/>
                  </a:cubicBezTo>
                  <a:cubicBezTo>
                    <a:pt x="869" y="335"/>
                    <a:pt x="909" y="331"/>
                    <a:pt x="933" y="329"/>
                  </a:cubicBezTo>
                  <a:cubicBezTo>
                    <a:pt x="957" y="327"/>
                    <a:pt x="969" y="325"/>
                    <a:pt x="982" y="323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496960" y="5965560"/>
              <a:ext cx="362160" cy="12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oup 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173480" y="2498400"/>
              <a:ext cx="455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oup 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668320" y="2327400"/>
              <a:ext cx="513000" cy="12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oup I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1" name=""/>
            <p:cNvGrpSpPr/>
            <p:nvPr/>
          </p:nvGrpSpPr>
          <p:grpSpPr>
            <a:xfrm>
              <a:off x="4012920" y="5819400"/>
              <a:ext cx="1326960" cy="345960"/>
              <a:chOff x="4012920" y="5819400"/>
              <a:chExt cx="1326960" cy="345960"/>
            </a:xfrm>
          </p:grpSpPr>
          <p:sp>
            <p:nvSpPr>
              <p:cNvPr id="172" name=""/>
              <p:cNvSpPr/>
              <p:nvPr/>
            </p:nvSpPr>
            <p:spPr>
              <a:xfrm>
                <a:off x="4036320" y="5949360"/>
                <a:ext cx="193320" cy="180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4098240" y="5819400"/>
                <a:ext cx="997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4119120" y="6073200"/>
                <a:ext cx="109872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639,000-860,000  (chromosome 3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4413960" y="5819400"/>
                <a:ext cx="105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4735800" y="5819400"/>
                <a:ext cx="102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4355280" y="5949360"/>
                <a:ext cx="193320" cy="180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705560" y="5949360"/>
                <a:ext cx="193320" cy="180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146560" y="5949360"/>
                <a:ext cx="193320" cy="180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5176800" y="5819400"/>
                <a:ext cx="997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 flipH="1">
                <a:off x="4965840" y="5971680"/>
                <a:ext cx="18720" cy="8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H="1">
                <a:off x="5004000" y="5971680"/>
                <a:ext cx="18720" cy="8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012920" y="6013080"/>
                <a:ext cx="957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5018040" y="6013080"/>
                <a:ext cx="282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5" name=""/>
            <p:cNvSpPr/>
            <p:nvPr/>
          </p:nvSpPr>
          <p:spPr>
            <a:xfrm rot="15390000">
              <a:off x="3702240" y="5631480"/>
              <a:ext cx="42480" cy="460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H="1" flipV="1" rot="5400000">
              <a:off x="3355920" y="4007880"/>
              <a:ext cx="42480" cy="460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rot="8242200">
              <a:off x="3504240" y="412380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rot="16447200">
              <a:off x="3365280" y="3888720"/>
              <a:ext cx="42480" cy="493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rot="541200">
              <a:off x="2177640" y="362880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 rot="14206200">
              <a:off x="3553920" y="4547520"/>
              <a:ext cx="42480" cy="4284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rot="18285000">
              <a:off x="3592080" y="3871440"/>
              <a:ext cx="42480" cy="493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rot="19974600">
              <a:off x="3711600" y="4080960"/>
              <a:ext cx="410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rot="1990200">
              <a:off x="3501360" y="4463640"/>
              <a:ext cx="4140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H="1" flipV="1" rot="14103000">
              <a:off x="3323520" y="413568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rot="2493600">
              <a:off x="3773160" y="4619160"/>
              <a:ext cx="428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rot="13778400">
              <a:off x="3094920" y="396756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rot="18482400">
              <a:off x="3152520" y="468900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H="1" flipV="1" rot="7356600">
              <a:off x="3301200" y="4711320"/>
              <a:ext cx="42840" cy="496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rot="12894000">
              <a:off x="3209760" y="4260240"/>
              <a:ext cx="446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rot="14264400">
              <a:off x="2838240" y="3017160"/>
              <a:ext cx="42480" cy="4608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H="1" flipV="1" rot="7356600">
              <a:off x="3455640" y="408060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rot="21172800">
              <a:off x="3546000" y="4252680"/>
              <a:ext cx="4140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rot="11341200">
              <a:off x="3768480" y="4482720"/>
              <a:ext cx="446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rot="17920800">
              <a:off x="3336120" y="4448160"/>
              <a:ext cx="424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rot="19753800">
              <a:off x="3162240" y="4447440"/>
              <a:ext cx="4284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rot="19915800">
              <a:off x="3258720" y="4385520"/>
              <a:ext cx="442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rot="11341200">
              <a:off x="3660480" y="4453920"/>
              <a:ext cx="4320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2647800" y="2882160"/>
              <a:ext cx="58680" cy="2196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 flipV="1">
              <a:off x="3089160" y="2648880"/>
              <a:ext cx="95400" cy="2340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362040" y="2639880"/>
              <a:ext cx="95400" cy="1224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892320" y="2734920"/>
              <a:ext cx="79560" cy="313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225680" y="2877840"/>
              <a:ext cx="79560" cy="5220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638600" y="3566880"/>
              <a:ext cx="33120" cy="6624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067000" y="3914640"/>
              <a:ext cx="22320" cy="14724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3T20:47:33Z</dcterms:created>
  <dc:creator>haobo</dc:creator>
  <dc:description/>
  <dc:language>en-US</dc:language>
  <cp:lastModifiedBy>Haobo Jiang</cp:lastModifiedBy>
  <dcterms:modified xsi:type="dcterms:W3CDTF">2007-08-08T18:30:22Z</dcterms:modified>
  <cp:revision>103</cp:revision>
  <dc:subject/>
  <dc:title>Slide 1</dc:title>
</cp:coreProperties>
</file>